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0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6433" autoAdjust="0"/>
  </p:normalViewPr>
  <p:slideViewPr>
    <p:cSldViewPr snapToGrid="0">
      <p:cViewPr varScale="1">
        <p:scale>
          <a:sx n="56" d="100"/>
          <a:sy n="56" d="100"/>
        </p:scale>
        <p:origin x="2106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BB3CE0-A6EC-4AD1-9E4F-9645D78C58F6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9F8E10-5540-4546-AC4D-5F3C1203C6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9236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375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130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513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22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49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90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215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625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913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508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828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F9B6A-0285-4DA3-9F8D-725F6014316E}" type="datetimeFigureOut">
              <a:rPr lang="en-US" smtClean="0"/>
              <a:t>6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B682D-0EC1-480C-A58F-4B2A94500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929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3045894" y="7914469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Supplemental Table 1</a:t>
            </a:r>
            <a:endParaRPr lang="en-US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5710547"/>
              </p:ext>
            </p:extLst>
          </p:nvPr>
        </p:nvGraphicFramePr>
        <p:xfrm>
          <a:off x="1019175" y="1670050"/>
          <a:ext cx="4984232" cy="61431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2642"/>
                <a:gridCol w="602642"/>
                <a:gridCol w="655420"/>
                <a:gridCol w="602642"/>
                <a:gridCol w="602642"/>
                <a:gridCol w="602642"/>
                <a:gridCol w="660182"/>
                <a:gridCol w="655420"/>
              </a:tblGrid>
              <a:tr h="340869"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rcent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nal</a:t>
                      </a:r>
                      <a:r>
                        <a:rPr lang="en-US" sz="11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ntensity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Relative to DMSO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34086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Perce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err="1">
                          <a:effectLst/>
                        </a:rPr>
                        <a:t>pFAK</a:t>
                      </a:r>
                      <a:r>
                        <a:rPr lang="en-US" sz="1100" u="none" strike="noStrike" dirty="0">
                          <a:effectLst/>
                        </a:rPr>
                        <a:t> Y8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pERK1/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S6 S2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S6 S2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AKT T3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err="1">
                          <a:effectLst/>
                        </a:rPr>
                        <a:t>pAKT</a:t>
                      </a:r>
                      <a:r>
                        <a:rPr lang="en-US" sz="1100" u="none" strike="noStrike" dirty="0">
                          <a:effectLst/>
                        </a:rPr>
                        <a:t> S47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BCPA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MS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38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1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34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3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7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62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mb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34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5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8505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MS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3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6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4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7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5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2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8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8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1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3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mb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7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6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9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2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MS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2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1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6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4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42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4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1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7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3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8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4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mb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6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4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3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8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97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l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MS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4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9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9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4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3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54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9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6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mb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8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55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6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MS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62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42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23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9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3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25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1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4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mb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1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HJ16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MS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4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0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23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47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82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9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34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5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1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3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  <a:tr h="18832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mb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9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1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6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40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16" marR="9416" marT="9416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72640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1</TotalTime>
  <Words>198</Words>
  <Application>Microsoft Office PowerPoint</Application>
  <PresentationFormat>Letter Paper (8.5x11 in)</PresentationFormat>
  <Paragraphs>18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dnell, Thomas</dc:creator>
  <cp:lastModifiedBy>Keiran Beadnell</cp:lastModifiedBy>
  <cp:revision>61</cp:revision>
  <dcterms:created xsi:type="dcterms:W3CDTF">2017-05-01T20:54:24Z</dcterms:created>
  <dcterms:modified xsi:type="dcterms:W3CDTF">2017-06-08T20:14:27Z</dcterms:modified>
</cp:coreProperties>
</file>